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025" autoAdjust="0"/>
    <p:restoredTop sz="94660"/>
  </p:normalViewPr>
  <p:slideViewPr>
    <p:cSldViewPr snapToGrid="0">
      <p:cViewPr varScale="1">
        <p:scale>
          <a:sx n="105" d="100"/>
          <a:sy n="105" d="100"/>
        </p:scale>
        <p:origin x="120" y="2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D22CB2-BA65-474F-92BF-7C8CE81C0CD8}" type="datetimeFigureOut">
              <a:rPr lang="fr-FR" smtClean="0"/>
              <a:t>29/04/202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DFE1A2-04FB-4516-8997-64D32797BFD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343690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D22CB2-BA65-474F-92BF-7C8CE81C0CD8}" type="datetimeFigureOut">
              <a:rPr lang="fr-FR" smtClean="0"/>
              <a:t>29/04/202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DFE1A2-04FB-4516-8997-64D32797BFD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523177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D22CB2-BA65-474F-92BF-7C8CE81C0CD8}" type="datetimeFigureOut">
              <a:rPr lang="fr-FR" smtClean="0"/>
              <a:t>29/04/202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DFE1A2-04FB-4516-8997-64D32797BFD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886249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D22CB2-BA65-474F-92BF-7C8CE81C0CD8}" type="datetimeFigureOut">
              <a:rPr lang="fr-FR" smtClean="0"/>
              <a:t>29/04/202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DFE1A2-04FB-4516-8997-64D32797BFD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606565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D22CB2-BA65-474F-92BF-7C8CE81C0CD8}" type="datetimeFigureOut">
              <a:rPr lang="fr-FR" smtClean="0"/>
              <a:t>29/04/202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DFE1A2-04FB-4516-8997-64D32797BFD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669822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D22CB2-BA65-474F-92BF-7C8CE81C0CD8}" type="datetimeFigureOut">
              <a:rPr lang="fr-FR" smtClean="0"/>
              <a:t>29/04/202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DFE1A2-04FB-4516-8997-64D32797BFD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332103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D22CB2-BA65-474F-92BF-7C8CE81C0CD8}" type="datetimeFigureOut">
              <a:rPr lang="fr-FR" smtClean="0"/>
              <a:t>29/04/2024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DFE1A2-04FB-4516-8997-64D32797BFD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136181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D22CB2-BA65-474F-92BF-7C8CE81C0CD8}" type="datetimeFigureOut">
              <a:rPr lang="fr-FR" smtClean="0"/>
              <a:t>29/04/2024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DFE1A2-04FB-4516-8997-64D32797BFD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631568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D22CB2-BA65-474F-92BF-7C8CE81C0CD8}" type="datetimeFigureOut">
              <a:rPr lang="fr-FR" smtClean="0"/>
              <a:t>29/04/2024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DFE1A2-04FB-4516-8997-64D32797BFD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4734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D22CB2-BA65-474F-92BF-7C8CE81C0CD8}" type="datetimeFigureOut">
              <a:rPr lang="fr-FR" smtClean="0"/>
              <a:t>29/04/202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DFE1A2-04FB-4516-8997-64D32797BFD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734568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D22CB2-BA65-474F-92BF-7C8CE81C0CD8}" type="datetimeFigureOut">
              <a:rPr lang="fr-FR" smtClean="0"/>
              <a:t>29/04/202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DFE1A2-04FB-4516-8997-64D32797BFD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656982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D22CB2-BA65-474F-92BF-7C8CE81C0CD8}" type="datetimeFigureOut">
              <a:rPr lang="fr-FR" smtClean="0"/>
              <a:t>29/04/202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DFE1A2-04FB-4516-8997-64D32797BFD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833123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Objet 2"/>
          <p:cNvGraphicFramePr>
            <a:graphicFrameLocks noChangeAspect="1"/>
          </p:cNvGraphicFramePr>
          <p:nvPr>
            <p:extLst/>
          </p:nvPr>
        </p:nvGraphicFramePr>
        <p:xfrm>
          <a:off x="5273965" y="1935081"/>
          <a:ext cx="2429163" cy="281611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6" name="Prism 8" r:id="rId3" imgW="2997410" imgH="3575249" progId="Prism8.Document">
                  <p:embed/>
                </p:oleObj>
              </mc:Choice>
              <mc:Fallback>
                <p:oleObj name="Prism 8" r:id="rId3" imgW="2997410" imgH="3575249" progId="Prism8.Document">
                  <p:embed/>
                  <p:pic>
                    <p:nvPicPr>
                      <p:cNvPr id="3" name="Objet 2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5273965" y="1935081"/>
                        <a:ext cx="2429163" cy="281611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t 3"/>
          <p:cNvGraphicFramePr>
            <a:graphicFrameLocks noChangeAspect="1"/>
          </p:cNvGraphicFramePr>
          <p:nvPr>
            <p:extLst/>
          </p:nvPr>
        </p:nvGraphicFramePr>
        <p:xfrm>
          <a:off x="2878137" y="1935082"/>
          <a:ext cx="2312699" cy="281676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7" name="Prism 8" r:id="rId5" imgW="2934746" imgH="3575249" progId="Prism8.Document">
                  <p:embed/>
                </p:oleObj>
              </mc:Choice>
              <mc:Fallback>
                <p:oleObj name="Prism 8" r:id="rId5" imgW="2934746" imgH="3575249" progId="Prism8.Document">
                  <p:embed/>
                  <p:pic>
                    <p:nvPicPr>
                      <p:cNvPr id="4" name="Objet 3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878137" y="1935082"/>
                        <a:ext cx="2312699" cy="281676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ZoneTexte 5">
            <a:extLst>
              <a:ext uri="{FF2B5EF4-FFF2-40B4-BE49-F238E27FC236}">
                <a16:creationId xmlns:a16="http://schemas.microsoft.com/office/drawing/2014/main" id="{B86BEFA6-CE95-432B-8AD3-3DF802935EB8}"/>
              </a:ext>
            </a:extLst>
          </p:cNvPr>
          <p:cNvSpPr txBox="1"/>
          <p:nvPr/>
        </p:nvSpPr>
        <p:spPr>
          <a:xfrm>
            <a:off x="1744986" y="534913"/>
            <a:ext cx="812868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/>
              <a:t>Figure S1. A) Fasting insulin levels in pM and B) area under the curve of glucose-stimulated insulin concentration</a:t>
            </a:r>
            <a:endParaRPr lang="fr-FR" dirty="0"/>
          </a:p>
        </p:txBody>
      </p:sp>
      <p:sp>
        <p:nvSpPr>
          <p:cNvPr id="7" name="Rectangle 6"/>
          <p:cNvSpPr/>
          <p:nvPr/>
        </p:nvSpPr>
        <p:spPr>
          <a:xfrm>
            <a:off x="2615999" y="1565748"/>
            <a:ext cx="44114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/>
              <a:t>A) </a:t>
            </a:r>
          </a:p>
        </p:txBody>
      </p:sp>
      <p:sp>
        <p:nvSpPr>
          <p:cNvPr id="8" name="Rectangle 7"/>
          <p:cNvSpPr/>
          <p:nvPr/>
        </p:nvSpPr>
        <p:spPr>
          <a:xfrm>
            <a:off x="5053391" y="1565748"/>
            <a:ext cx="43313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/>
              <a:t>B) </a:t>
            </a:r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59646832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5</Words>
  <Application>Microsoft Office PowerPoint</Application>
  <PresentationFormat>Grand écran</PresentationFormat>
  <Paragraphs>3</Paragraphs>
  <Slides>1</Slides>
  <Notes>0</Notes>
  <HiddenSlides>0</HiddenSlides>
  <MMClips>0</MMClips>
  <ScaleCrop>false</ScaleCrop>
  <HeadingPairs>
    <vt:vector size="8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Serveurs OLE incorporés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hème Office</vt:lpstr>
      <vt:lpstr>Prism 8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Jean-Marc Chatel</dc:creator>
  <cp:lastModifiedBy>Jean-Marc Chatel</cp:lastModifiedBy>
  <cp:revision>1</cp:revision>
  <dcterms:created xsi:type="dcterms:W3CDTF">2024-04-29T12:46:56Z</dcterms:created>
  <dcterms:modified xsi:type="dcterms:W3CDTF">2024-04-29T12:47:15Z</dcterms:modified>
</cp:coreProperties>
</file>